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-462" y="-4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cmu\exosome\KU812\202209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4756825036890208E-2"/>
          <c:y val="0.12248325487007342"/>
          <c:w val="0.92514404721774779"/>
          <c:h val="0.81296098114363968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工作表2!$B$6:$X$6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0.11398851620448297</c:v>
                  </c:pt>
                  <c:pt idx="2">
                    <c:v>2.3867542643259344E-2</c:v>
                  </c:pt>
                  <c:pt idx="3">
                    <c:v>3.553867399948403E-2</c:v>
                  </c:pt>
                  <c:pt idx="4">
                    <c:v>1.8363150615607234E-2</c:v>
                  </c:pt>
                  <c:pt idx="6">
                    <c:v>0</c:v>
                  </c:pt>
                  <c:pt idx="7">
                    <c:v>8.5637041498768732E-2</c:v>
                  </c:pt>
                  <c:pt idx="8">
                    <c:v>6.3892543893816545E-2</c:v>
                  </c:pt>
                  <c:pt idx="9">
                    <c:v>4.4482221405318094E-2</c:v>
                  </c:pt>
                  <c:pt idx="10">
                    <c:v>7.2321576316649219E-2</c:v>
                  </c:pt>
                  <c:pt idx="12">
                    <c:v>0</c:v>
                  </c:pt>
                  <c:pt idx="13">
                    <c:v>0.12862567511616405</c:v>
                  </c:pt>
                  <c:pt idx="14">
                    <c:v>3.600946925542664E-2</c:v>
                  </c:pt>
                  <c:pt idx="15">
                    <c:v>4.2602281105184471E-2</c:v>
                  </c:pt>
                  <c:pt idx="16">
                    <c:v>0.23307761809797944</c:v>
                  </c:pt>
                  <c:pt idx="18">
                    <c:v>0</c:v>
                  </c:pt>
                  <c:pt idx="19">
                    <c:v>5.7300412034371709E-2</c:v>
                  </c:pt>
                  <c:pt idx="20">
                    <c:v>1.9711405168576685E-2</c:v>
                  </c:pt>
                  <c:pt idx="21">
                    <c:v>2.3859227186886288E-2</c:v>
                  </c:pt>
                  <c:pt idx="22">
                    <c:v>1.434716518735912E-2</c:v>
                  </c:pt>
                </c:numCache>
              </c:numRef>
            </c:plus>
            <c:minus>
              <c:numRef>
                <c:f>工作表2!$B$6:$X$6</c:f>
                <c:numCache>
                  <c:formatCode>General</c:formatCode>
                  <c:ptCount val="23"/>
                  <c:pt idx="0">
                    <c:v>0</c:v>
                  </c:pt>
                  <c:pt idx="1">
                    <c:v>0.11398851620448297</c:v>
                  </c:pt>
                  <c:pt idx="2">
                    <c:v>2.3867542643259344E-2</c:v>
                  </c:pt>
                  <c:pt idx="3">
                    <c:v>3.553867399948403E-2</c:v>
                  </c:pt>
                  <c:pt idx="4">
                    <c:v>1.8363150615607234E-2</c:v>
                  </c:pt>
                  <c:pt idx="6">
                    <c:v>0</c:v>
                  </c:pt>
                  <c:pt idx="7">
                    <c:v>8.5637041498768732E-2</c:v>
                  </c:pt>
                  <c:pt idx="8">
                    <c:v>6.3892543893816545E-2</c:v>
                  </c:pt>
                  <c:pt idx="9">
                    <c:v>4.4482221405318094E-2</c:v>
                  </c:pt>
                  <c:pt idx="10">
                    <c:v>7.2321576316649219E-2</c:v>
                  </c:pt>
                  <c:pt idx="12">
                    <c:v>0</c:v>
                  </c:pt>
                  <c:pt idx="13">
                    <c:v>0.12862567511616405</c:v>
                  </c:pt>
                  <c:pt idx="14">
                    <c:v>3.600946925542664E-2</c:v>
                  </c:pt>
                  <c:pt idx="15">
                    <c:v>4.2602281105184471E-2</c:v>
                  </c:pt>
                  <c:pt idx="16">
                    <c:v>0.23307761809797944</c:v>
                  </c:pt>
                  <c:pt idx="18">
                    <c:v>0</c:v>
                  </c:pt>
                  <c:pt idx="19">
                    <c:v>5.7300412034371709E-2</c:v>
                  </c:pt>
                  <c:pt idx="20">
                    <c:v>1.9711405168576685E-2</c:v>
                  </c:pt>
                  <c:pt idx="21">
                    <c:v>2.3859227186886288E-2</c:v>
                  </c:pt>
                  <c:pt idx="22">
                    <c:v>1.4347165187359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工作表2!$B$4:$X$4</c:f>
              <c:strCache>
                <c:ptCount val="23"/>
                <c:pt idx="0">
                  <c:v>control</c:v>
                </c:pt>
                <c:pt idx="2">
                  <c:v>10^7</c:v>
                </c:pt>
                <c:pt idx="3">
                  <c:v>10^8</c:v>
                </c:pt>
                <c:pt idx="4">
                  <c:v>10^9</c:v>
                </c:pt>
                <c:pt idx="6">
                  <c:v>control</c:v>
                </c:pt>
                <c:pt idx="8">
                  <c:v>10^7</c:v>
                </c:pt>
                <c:pt idx="9">
                  <c:v>10^8</c:v>
                </c:pt>
                <c:pt idx="10">
                  <c:v>10^9</c:v>
                </c:pt>
                <c:pt idx="12">
                  <c:v>control</c:v>
                </c:pt>
                <c:pt idx="14">
                  <c:v>10^7</c:v>
                </c:pt>
                <c:pt idx="15">
                  <c:v>10^8</c:v>
                </c:pt>
                <c:pt idx="16">
                  <c:v>10^9</c:v>
                </c:pt>
                <c:pt idx="18">
                  <c:v>control</c:v>
                </c:pt>
                <c:pt idx="20">
                  <c:v>10^7</c:v>
                </c:pt>
                <c:pt idx="21">
                  <c:v>10^8</c:v>
                </c:pt>
                <c:pt idx="22">
                  <c:v>10^9</c:v>
                </c:pt>
              </c:strCache>
            </c:strRef>
          </c:cat>
          <c:val>
            <c:numRef>
              <c:f>工作表2!$B$5:$X$5</c:f>
              <c:numCache>
                <c:formatCode>General</c:formatCode>
                <c:ptCount val="23"/>
                <c:pt idx="0">
                  <c:v>1</c:v>
                </c:pt>
                <c:pt idx="1">
                  <c:v>1.5176079748687836</c:v>
                </c:pt>
                <c:pt idx="2">
                  <c:v>0.97220502591340896</c:v>
                </c:pt>
                <c:pt idx="3">
                  <c:v>0.96464283000857221</c:v>
                </c:pt>
                <c:pt idx="4">
                  <c:v>0.64642666235790358</c:v>
                </c:pt>
                <c:pt idx="6">
                  <c:v>1</c:v>
                </c:pt>
                <c:pt idx="7">
                  <c:v>2.9007280427208655</c:v>
                </c:pt>
                <c:pt idx="8">
                  <c:v>1.7299627988397981</c:v>
                </c:pt>
                <c:pt idx="9">
                  <c:v>0.25502426344765733</c:v>
                </c:pt>
                <c:pt idx="10">
                  <c:v>0.34443430997591234</c:v>
                </c:pt>
                <c:pt idx="12">
                  <c:v>1</c:v>
                </c:pt>
                <c:pt idx="13">
                  <c:v>1.5082191964359655</c:v>
                </c:pt>
                <c:pt idx="14">
                  <c:v>1.2581701721545706</c:v>
                </c:pt>
                <c:pt idx="15">
                  <c:v>1.0216761124506937</c:v>
                </c:pt>
                <c:pt idx="16">
                  <c:v>1.08245604417743</c:v>
                </c:pt>
                <c:pt idx="18">
                  <c:v>1</c:v>
                </c:pt>
                <c:pt idx="19">
                  <c:v>1.4186836613766272</c:v>
                </c:pt>
                <c:pt idx="20">
                  <c:v>0.93857373997286919</c:v>
                </c:pt>
                <c:pt idx="21">
                  <c:v>0.73955050889721052</c:v>
                </c:pt>
                <c:pt idx="22">
                  <c:v>0.68456315326742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B5-49D4-83A4-F52D35C83B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74"/>
        <c:axId val="2020606336"/>
        <c:axId val="2020616320"/>
      </c:barChart>
      <c:catAx>
        <c:axId val="2020606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0616320"/>
        <c:crosses val="autoZero"/>
        <c:auto val="1"/>
        <c:lblAlgn val="ctr"/>
        <c:lblOffset val="100"/>
        <c:noMultiLvlLbl val="0"/>
      </c:catAx>
      <c:valAx>
        <c:axId val="20206163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TW" sz="1200"/>
                  <a:t>Relative</a:t>
                </a:r>
                <a:r>
                  <a:rPr lang="en-US" altLang="zh-TW" sz="1200" baseline="0"/>
                  <a:t> protein level</a:t>
                </a:r>
                <a:endParaRPr lang="zh-TW" altLang="en-US" sz="1200"/>
              </a:p>
            </c:rich>
          </c:tx>
          <c:layout>
            <c:manualLayout>
              <c:xMode val="edge"/>
              <c:yMode val="edge"/>
              <c:x val="0"/>
              <c:y val="0.3442556380936310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206063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27702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0200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51256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02549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41004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01815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37517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80930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72075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79553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58740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5A6E1-7DB2-44F7-AC8B-23DB23E5CD5F}" type="datetimeFigureOut">
              <a:rPr lang="zh-TW" altLang="en-US" smtClean="0"/>
              <a:t>2022/11/1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9EB79F-9857-49C9-B750-497E33BA27A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01148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群組 20">
            <a:extLst>
              <a:ext uri="{FF2B5EF4-FFF2-40B4-BE49-F238E27FC236}">
                <a16:creationId xmlns:a16="http://schemas.microsoft.com/office/drawing/2014/main" id="{F1789EC8-56CC-093E-2DEE-610CBCE3341E}"/>
              </a:ext>
            </a:extLst>
          </p:cNvPr>
          <p:cNvGrpSpPr/>
          <p:nvPr/>
        </p:nvGrpSpPr>
        <p:grpSpPr>
          <a:xfrm>
            <a:off x="1233577" y="914400"/>
            <a:ext cx="9320902" cy="4354448"/>
            <a:chOff x="1669490" y="914400"/>
            <a:chExt cx="8884989" cy="4354448"/>
          </a:xfrm>
        </p:grpSpPr>
        <p:grpSp>
          <p:nvGrpSpPr>
            <p:cNvPr id="11" name="群組 10">
              <a:extLst>
                <a:ext uri="{FF2B5EF4-FFF2-40B4-BE49-F238E27FC236}">
                  <a16:creationId xmlns:a16="http://schemas.microsoft.com/office/drawing/2014/main" id="{7E5B243E-35C7-7175-4A15-BBD4ADCD36FF}"/>
                </a:ext>
              </a:extLst>
            </p:cNvPr>
            <p:cNvGrpSpPr/>
            <p:nvPr/>
          </p:nvGrpSpPr>
          <p:grpSpPr>
            <a:xfrm>
              <a:off x="1669490" y="914400"/>
              <a:ext cx="8884989" cy="4103642"/>
              <a:chOff x="1772126" y="1576873"/>
              <a:chExt cx="8884989" cy="4103642"/>
            </a:xfrm>
          </p:grpSpPr>
          <p:graphicFrame>
            <p:nvGraphicFramePr>
              <p:cNvPr id="6" name="圖表 5">
                <a:extLst>
                  <a:ext uri="{FF2B5EF4-FFF2-40B4-BE49-F238E27FC236}">
                    <a16:creationId xmlns:a16="http://schemas.microsoft.com/office/drawing/2014/main" id="{BA4E460C-ADF7-EF02-46C1-F69E5B14F1D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75348508"/>
                  </p:ext>
                </p:extLst>
              </p:nvPr>
            </p:nvGraphicFramePr>
            <p:xfrm>
              <a:off x="1772126" y="1576873"/>
              <a:ext cx="8884989" cy="386380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" name="文字方塊 1">
                <a:extLst>
                  <a:ext uri="{FF2B5EF4-FFF2-40B4-BE49-F238E27FC236}">
                    <a16:creationId xmlns:a16="http://schemas.microsoft.com/office/drawing/2014/main" id="{7FA484DA-F195-E53B-8A99-23D513C676E9}"/>
                  </a:ext>
                </a:extLst>
              </p:cNvPr>
              <p:cNvSpPr txBox="1"/>
              <p:nvPr/>
            </p:nvSpPr>
            <p:spPr>
              <a:xfrm>
                <a:off x="2933201" y="5412686"/>
                <a:ext cx="35458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050" dirty="0"/>
                  <a:t>IgE</a:t>
                </a:r>
                <a:endParaRPr lang="zh-TW" altLang="en-US" sz="1050" dirty="0"/>
              </a:p>
            </p:txBody>
          </p:sp>
          <p:cxnSp>
            <p:nvCxnSpPr>
              <p:cNvPr id="3" name="直線接點 2">
                <a:extLst>
                  <a:ext uri="{FF2B5EF4-FFF2-40B4-BE49-F238E27FC236}">
                    <a16:creationId xmlns:a16="http://schemas.microsoft.com/office/drawing/2014/main" id="{D4DF70A2-24CE-1F94-EFD0-A225025753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08493" y="5412686"/>
                <a:ext cx="140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" name="文字方塊 3">
                <a:extLst>
                  <a:ext uri="{FF2B5EF4-FFF2-40B4-BE49-F238E27FC236}">
                    <a16:creationId xmlns:a16="http://schemas.microsoft.com/office/drawing/2014/main" id="{93A72626-B022-1E1D-4D9A-6C2212A13B09}"/>
                  </a:ext>
                </a:extLst>
              </p:cNvPr>
              <p:cNvSpPr txBox="1"/>
              <p:nvPr/>
            </p:nvSpPr>
            <p:spPr>
              <a:xfrm>
                <a:off x="5157000" y="5415795"/>
                <a:ext cx="35458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050" dirty="0"/>
                  <a:t>IgE</a:t>
                </a:r>
                <a:endParaRPr lang="zh-TW" altLang="en-US" sz="1050" dirty="0"/>
              </a:p>
            </p:txBody>
          </p:sp>
          <p:cxnSp>
            <p:nvCxnSpPr>
              <p:cNvPr id="5" name="直線接點 4">
                <a:extLst>
                  <a:ext uri="{FF2B5EF4-FFF2-40B4-BE49-F238E27FC236}">
                    <a16:creationId xmlns:a16="http://schemas.microsoft.com/office/drawing/2014/main" id="{A323EDDF-2EEF-A0A0-EEDF-43DDA8BAAF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32292" y="5415795"/>
                <a:ext cx="140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文字方塊 6">
                <a:extLst>
                  <a:ext uri="{FF2B5EF4-FFF2-40B4-BE49-F238E27FC236}">
                    <a16:creationId xmlns:a16="http://schemas.microsoft.com/office/drawing/2014/main" id="{1D9A4F41-A651-7A93-5232-0740AAE93731}"/>
                  </a:ext>
                </a:extLst>
              </p:cNvPr>
              <p:cNvSpPr txBox="1"/>
              <p:nvPr/>
            </p:nvSpPr>
            <p:spPr>
              <a:xfrm>
                <a:off x="7377676" y="5415796"/>
                <a:ext cx="35458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050" dirty="0"/>
                  <a:t>IgE</a:t>
                </a:r>
                <a:endParaRPr lang="zh-TW" altLang="en-US" sz="1050" dirty="0"/>
              </a:p>
            </p:txBody>
          </p:sp>
          <p:cxnSp>
            <p:nvCxnSpPr>
              <p:cNvPr id="8" name="直線接點 7">
                <a:extLst>
                  <a:ext uri="{FF2B5EF4-FFF2-40B4-BE49-F238E27FC236}">
                    <a16:creationId xmlns:a16="http://schemas.microsoft.com/office/drawing/2014/main" id="{DBD1067D-B1B9-C4A9-FCB2-15A60F1FCE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52968" y="5415796"/>
                <a:ext cx="140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" name="文字方塊 8">
                <a:extLst>
                  <a:ext uri="{FF2B5EF4-FFF2-40B4-BE49-F238E27FC236}">
                    <a16:creationId xmlns:a16="http://schemas.microsoft.com/office/drawing/2014/main" id="{95D7D955-5939-7DDF-CC9B-B97E79734218}"/>
                  </a:ext>
                </a:extLst>
              </p:cNvPr>
              <p:cNvSpPr txBox="1"/>
              <p:nvPr/>
            </p:nvSpPr>
            <p:spPr>
              <a:xfrm>
                <a:off x="9601475" y="5418905"/>
                <a:ext cx="35458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1050" dirty="0"/>
                  <a:t>IgE</a:t>
                </a:r>
                <a:endParaRPr lang="zh-TW" altLang="en-US" sz="1050" dirty="0"/>
              </a:p>
            </p:txBody>
          </p:sp>
          <p:cxnSp>
            <p:nvCxnSpPr>
              <p:cNvPr id="10" name="直線接點 9">
                <a:extLst>
                  <a:ext uri="{FF2B5EF4-FFF2-40B4-BE49-F238E27FC236}">
                    <a16:creationId xmlns:a16="http://schemas.microsoft.com/office/drawing/2014/main" id="{C9E890D8-D216-4E7F-83BE-3A62B9180F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076767" y="5418905"/>
                <a:ext cx="1404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3" name="直線接點 12">
              <a:extLst>
                <a:ext uri="{FF2B5EF4-FFF2-40B4-BE49-F238E27FC236}">
                  <a16:creationId xmlns:a16="http://schemas.microsoft.com/office/drawing/2014/main" id="{1C5206EA-92EC-C2AD-40E6-4CBD55C61A32}"/>
                </a:ext>
              </a:extLst>
            </p:cNvPr>
            <p:cNvCxnSpPr/>
            <p:nvPr/>
          </p:nvCxnSpPr>
          <p:spPr>
            <a:xfrm>
              <a:off x="2080381" y="5011823"/>
              <a:ext cx="188740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文字方塊 13">
              <a:extLst>
                <a:ext uri="{FF2B5EF4-FFF2-40B4-BE49-F238E27FC236}">
                  <a16:creationId xmlns:a16="http://schemas.microsoft.com/office/drawing/2014/main" id="{783D253B-7DF8-2756-4FAF-B7CE00883DF4}"/>
                </a:ext>
              </a:extLst>
            </p:cNvPr>
            <p:cNvSpPr txBox="1"/>
            <p:nvPr/>
          </p:nvSpPr>
          <p:spPr>
            <a:xfrm>
              <a:off x="2289086" y="5011823"/>
              <a:ext cx="98937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50" dirty="0"/>
                <a:t>pSTAT5/STAT5</a:t>
              </a:r>
              <a:endParaRPr lang="zh-TW" altLang="en-US" sz="1050" dirty="0"/>
            </a:p>
          </p:txBody>
        </p:sp>
        <p:cxnSp>
          <p:nvCxnSpPr>
            <p:cNvPr id="15" name="直線接點 14">
              <a:extLst>
                <a:ext uri="{FF2B5EF4-FFF2-40B4-BE49-F238E27FC236}">
                  <a16:creationId xmlns:a16="http://schemas.microsoft.com/office/drawing/2014/main" id="{07154327-DB19-DC2C-2B73-454A51C34538}"/>
                </a:ext>
              </a:extLst>
            </p:cNvPr>
            <p:cNvCxnSpPr/>
            <p:nvPr/>
          </p:nvCxnSpPr>
          <p:spPr>
            <a:xfrm>
              <a:off x="4318990" y="5011823"/>
              <a:ext cx="181876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文字方塊 15">
              <a:extLst>
                <a:ext uri="{FF2B5EF4-FFF2-40B4-BE49-F238E27FC236}">
                  <a16:creationId xmlns:a16="http://schemas.microsoft.com/office/drawing/2014/main" id="{97B3A991-6D48-8895-571B-490639788E2B}"/>
                </a:ext>
              </a:extLst>
            </p:cNvPr>
            <p:cNvSpPr txBox="1"/>
            <p:nvPr/>
          </p:nvSpPr>
          <p:spPr>
            <a:xfrm>
              <a:off x="4692687" y="5011823"/>
              <a:ext cx="70724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50" dirty="0"/>
                <a:t>pJNK/JNK</a:t>
              </a:r>
              <a:endParaRPr lang="zh-TW" altLang="en-US" sz="1050" dirty="0"/>
            </a:p>
          </p:txBody>
        </p:sp>
        <p:cxnSp>
          <p:nvCxnSpPr>
            <p:cNvPr id="17" name="直線接點 16">
              <a:extLst>
                <a:ext uri="{FF2B5EF4-FFF2-40B4-BE49-F238E27FC236}">
                  <a16:creationId xmlns:a16="http://schemas.microsoft.com/office/drawing/2014/main" id="{D977428C-8FB9-A8F0-210E-00D3F686719D}"/>
                </a:ext>
              </a:extLst>
            </p:cNvPr>
            <p:cNvCxnSpPr/>
            <p:nvPr/>
          </p:nvCxnSpPr>
          <p:spPr>
            <a:xfrm>
              <a:off x="6454963" y="5011823"/>
              <a:ext cx="178445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文字方塊 17">
              <a:extLst>
                <a:ext uri="{FF2B5EF4-FFF2-40B4-BE49-F238E27FC236}">
                  <a16:creationId xmlns:a16="http://schemas.microsoft.com/office/drawing/2014/main" id="{816582D5-90D4-9BD1-E164-16A686260749}"/>
                </a:ext>
              </a:extLst>
            </p:cNvPr>
            <p:cNvSpPr txBox="1"/>
            <p:nvPr/>
          </p:nvSpPr>
          <p:spPr>
            <a:xfrm>
              <a:off x="6932512" y="5011823"/>
              <a:ext cx="72006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50" dirty="0"/>
                <a:t>pP38/P38</a:t>
              </a:r>
              <a:endParaRPr lang="zh-TW" altLang="en-US" sz="1050" dirty="0"/>
            </a:p>
          </p:txBody>
        </p:sp>
        <p:cxnSp>
          <p:nvCxnSpPr>
            <p:cNvPr id="19" name="直線接點 18">
              <a:extLst>
                <a:ext uri="{FF2B5EF4-FFF2-40B4-BE49-F238E27FC236}">
                  <a16:creationId xmlns:a16="http://schemas.microsoft.com/office/drawing/2014/main" id="{D16154FF-10E6-670F-A3A9-7717E5A73DC0}"/>
                </a:ext>
              </a:extLst>
            </p:cNvPr>
            <p:cNvCxnSpPr/>
            <p:nvPr/>
          </p:nvCxnSpPr>
          <p:spPr>
            <a:xfrm>
              <a:off x="8619570" y="5011823"/>
              <a:ext cx="178445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文字方塊 19">
              <a:extLst>
                <a:ext uri="{FF2B5EF4-FFF2-40B4-BE49-F238E27FC236}">
                  <a16:creationId xmlns:a16="http://schemas.microsoft.com/office/drawing/2014/main" id="{18A73F22-AC45-B8BE-6DC7-0F4C3EC8035B}"/>
                </a:ext>
              </a:extLst>
            </p:cNvPr>
            <p:cNvSpPr txBox="1"/>
            <p:nvPr/>
          </p:nvSpPr>
          <p:spPr>
            <a:xfrm>
              <a:off x="9445626" y="5014932"/>
              <a:ext cx="3930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50" dirty="0"/>
                <a:t>p65</a:t>
              </a:r>
              <a:endParaRPr lang="zh-TW" altLang="en-US" sz="1050" dirty="0"/>
            </a:p>
          </p:txBody>
        </p:sp>
      </p:grpSp>
    </p:spTree>
    <p:extLst>
      <p:ext uri="{BB962C8B-B14F-4D97-AF65-F5344CB8AC3E}">
        <p14:creationId xmlns:p14="http://schemas.microsoft.com/office/powerpoint/2010/main" val="3548092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</TotalTime>
  <Words>17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Hope Huang Hope Huang</dc:creator>
  <cp:lastModifiedBy>MDPI</cp:lastModifiedBy>
  <cp:revision>19</cp:revision>
  <dcterms:created xsi:type="dcterms:W3CDTF">2022-06-07T07:20:26Z</dcterms:created>
  <dcterms:modified xsi:type="dcterms:W3CDTF">2022-11-17T05:42:39Z</dcterms:modified>
</cp:coreProperties>
</file>